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79549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88"/>
    <p:restoredTop sz="94634"/>
  </p:normalViewPr>
  <p:slideViewPr>
    <p:cSldViewPr snapToGrid="0" snapToObjects="1">
      <p:cViewPr varScale="1">
        <p:scale>
          <a:sx n="148" d="100"/>
          <a:sy n="148" d="100"/>
        </p:scale>
        <p:origin x="167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liciasalinero:Desktop:Grad%20School:4-5-13%20Western%20Quantific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Ty1 </a:t>
            </a:r>
            <a:r>
              <a:rPr lang="en-US" dirty="0" smtClean="0"/>
              <a:t>GAG Expression</a:t>
            </a:r>
            <a:endParaRPr lang="en-US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43283682765407"/>
          <c:y val="0.175671469878621"/>
          <c:w val="0.823576480920109"/>
          <c:h val="0.590995906141851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round/>
                <a:headEnd type="none" w="med" len="med"/>
                <a:tailEnd type="none" w="med" len="med"/>
              </a:ln>
            </c:spPr>
          </c:dPt>
          <c:dPt>
            <c:idx val="1"/>
            <c:invertIfNegative val="0"/>
            <c:bubble3D val="0"/>
            <c:spPr>
              <a:solidFill>
                <a:srgbClr val="A6A6A6"/>
              </a:solidFill>
              <a:ln>
                <a:solidFill>
                  <a:srgbClr val="000000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000000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F0"/>
              </a:solidFill>
              <a:ln>
                <a:solidFill>
                  <a:srgbClr val="000000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F0"/>
              </a:solidFill>
              <a:ln>
                <a:solidFill>
                  <a:srgbClr val="000000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rgbClr val="00B0F0"/>
              </a:solidFill>
              <a:ln>
                <a:solidFill>
                  <a:srgbClr val="000000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rgbClr val="FFFF00"/>
              </a:solidFill>
              <a:ln>
                <a:solidFill>
                  <a:srgbClr val="000000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rgbClr val="FFFF00"/>
              </a:solidFill>
              <a:ln>
                <a:solidFill>
                  <a:srgbClr val="000000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FFFF00"/>
              </a:solidFill>
              <a:ln>
                <a:solidFill>
                  <a:srgbClr val="000000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FFFF00"/>
              </a:solidFill>
              <a:ln>
                <a:solidFill>
                  <a:srgbClr val="000000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000000"/>
                </a:solidFill>
              </a:ln>
            </c:spPr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000000"/>
                </a:solidFill>
              </a:ln>
            </c:spPr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000000"/>
                </a:solidFill>
              </a:ln>
            </c:spPr>
          </c:dPt>
          <c:dPt>
            <c:idx val="14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000000"/>
                </a:solidFill>
              </a:ln>
            </c:spPr>
          </c:dPt>
          <c:cat>
            <c:strRef>
              <c:f>Sheet1!$L$70:$L$84</c:f>
              <c:strCache>
                <c:ptCount val="15"/>
                <c:pt idx="0">
                  <c:v>WT</c:v>
                </c:pt>
                <c:pt idx="1">
                  <c:v>spt3Δ</c:v>
                </c:pt>
                <c:pt idx="2">
                  <c:v>srb2Δ</c:v>
                </c:pt>
                <c:pt idx="3">
                  <c:v>srb5Δ</c:v>
                </c:pt>
                <c:pt idx="4">
                  <c:v>soh1Δ</c:v>
                </c:pt>
                <c:pt idx="5">
                  <c:v>med1Δ</c:v>
                </c:pt>
                <c:pt idx="6">
                  <c:v>nut1Δ</c:v>
                </c:pt>
                <c:pt idx="7">
                  <c:v>sin4Δ</c:v>
                </c:pt>
                <c:pt idx="8">
                  <c:v>gal11Δ</c:v>
                </c:pt>
                <c:pt idx="9">
                  <c:v>med2Δ</c:v>
                </c:pt>
                <c:pt idx="10">
                  <c:v>pgd1Δ</c:v>
                </c:pt>
                <c:pt idx="11">
                  <c:v>cdk8Δ</c:v>
                </c:pt>
                <c:pt idx="12">
                  <c:v>med13Δ</c:v>
                </c:pt>
                <c:pt idx="13">
                  <c:v>srb11Δ</c:v>
                </c:pt>
                <c:pt idx="14">
                  <c:v>srb8Δ</c:v>
                </c:pt>
              </c:strCache>
            </c:strRef>
          </c:cat>
          <c:val>
            <c:numRef>
              <c:f>'[4-5-13 Western Quantification.xlsx]Sheet1'!$O$70,'[4-5-13 Western Quantification.xlsx]Sheet1'!$O$71,'[4-5-13 Western Quantification.xlsx]Sheet1'!$O$72,'[4-5-13 Western Quantification.xlsx]Sheet1'!$O$73,'[4-5-13 Western Quantification.xlsx]Sheet1'!$O$74,'[4-5-13 Western Quantification.xlsx]Sheet1'!$O$75,'[4-5-13 Western Quantification.xlsx]Sheet1'!$O$76,'[4-5-13 Western Quantification.xlsx]Sheet1'!$O$77,'[4-5-13 Western Quantification.xlsx]Sheet1'!$O$81,'[4-5-13 Western Quantification.xlsx]Sheet1'!$O$82,'[4-5-13 Western Quantification.xlsx]Sheet1'!$O$83,'[4-5-13 Western Quantification.xlsx]Sheet1'!$O$84,'[4-5-13 Western Quantification.xlsx]Sheet1'!$O$85,'[4-5-13 Western Quantification.xlsx]Sheet1'!$O$86,'[4-5-13 Western Quantification.xlsx]Sheet1'!$O$87</c:f>
              <c:numCache>
                <c:formatCode>General</c:formatCode>
                <c:ptCount val="15"/>
                <c:pt idx="0">
                  <c:v>1.0</c:v>
                </c:pt>
                <c:pt idx="1">
                  <c:v>0.04412181259725</c:v>
                </c:pt>
                <c:pt idx="2">
                  <c:v>1.12554578410391</c:v>
                </c:pt>
                <c:pt idx="3">
                  <c:v>0.803436310246293</c:v>
                </c:pt>
                <c:pt idx="4">
                  <c:v>1.325390811561414</c:v>
                </c:pt>
                <c:pt idx="5">
                  <c:v>1.02654863174855</c:v>
                </c:pt>
                <c:pt idx="6">
                  <c:v>0.875515010976514</c:v>
                </c:pt>
                <c:pt idx="7">
                  <c:v>0.770990613888827</c:v>
                </c:pt>
                <c:pt idx="8">
                  <c:v>0.704551234000201</c:v>
                </c:pt>
                <c:pt idx="9">
                  <c:v>0.605788121624043</c:v>
                </c:pt>
                <c:pt idx="10">
                  <c:v>0.477343940494772</c:v>
                </c:pt>
                <c:pt idx="11">
                  <c:v>0.783624467885877</c:v>
                </c:pt>
                <c:pt idx="12">
                  <c:v>1.124894768375715</c:v>
                </c:pt>
                <c:pt idx="13">
                  <c:v>0.809109513119064</c:v>
                </c:pt>
                <c:pt idx="14">
                  <c:v>0.7863446692059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9101104"/>
        <c:axId val="1639334624"/>
      </c:barChart>
      <c:catAx>
        <c:axId val="16391011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Mediator Subunit Deletion Strain</a:t>
                </a:r>
                <a:endParaRPr lang="en-US" dirty="0"/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i="1"/>
            </a:pPr>
            <a:endParaRPr lang="en-US"/>
          </a:p>
        </c:txPr>
        <c:crossAx val="1639334624"/>
        <c:crosses val="autoZero"/>
        <c:auto val="1"/>
        <c:lblAlgn val="ctr"/>
        <c:lblOffset val="100"/>
        <c:noMultiLvlLbl val="0"/>
      </c:catAx>
      <c:valAx>
        <c:axId val="1639334624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GAG Protein Expression (Arbitrary Units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0214926516101385"/>
              <c:y val="0.17567162043000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3910110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01889"/>
            <a:ext cx="5829300" cy="276950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178198"/>
            <a:ext cx="5143500" cy="192060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23528"/>
            <a:ext cx="1478756" cy="674146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23528"/>
            <a:ext cx="4350544" cy="674146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983219"/>
            <a:ext cx="5915025" cy="330904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323566"/>
            <a:ext cx="5915025" cy="174014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17641"/>
            <a:ext cx="2914650" cy="504735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17641"/>
            <a:ext cx="2914650" cy="504735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3530"/>
            <a:ext cx="5915025" cy="153759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50071"/>
            <a:ext cx="2901255" cy="95570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905771"/>
            <a:ext cx="2901255" cy="42739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50071"/>
            <a:ext cx="2915543" cy="95570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905771"/>
            <a:ext cx="2915543" cy="42739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0331"/>
            <a:ext cx="2211884" cy="185615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45369"/>
            <a:ext cx="3471863" cy="56531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86489"/>
            <a:ext cx="2211884" cy="442126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0331"/>
            <a:ext cx="2211884" cy="185615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45369"/>
            <a:ext cx="3471863" cy="56531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86489"/>
            <a:ext cx="2211884" cy="442126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23530"/>
            <a:ext cx="5915025" cy="15375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17641"/>
            <a:ext cx="5915025" cy="50473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373074"/>
            <a:ext cx="1543050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5746A-78EA-0D47-8EF0-6F8CB2979D80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373074"/>
            <a:ext cx="2314575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373074"/>
            <a:ext cx="1543050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BD396B-B6A7-2E48-9FAE-4BB8A3481B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335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30172" y="2204187"/>
            <a:ext cx="8793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12593" y="1891460"/>
            <a:ext cx="10350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49/p45-Gag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207470" y="1129138"/>
            <a:ext cx="484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d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488297" y="1125737"/>
            <a:ext cx="809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284126" y="1124439"/>
            <a:ext cx="478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il</a:t>
            </a:r>
          </a:p>
        </p:txBody>
      </p:sp>
      <p:sp>
        <p:nvSpPr>
          <p:cNvPr id="8" name="TextBox 11"/>
          <p:cNvSpPr txBox="1">
            <a:spLocks noChangeArrowheads="1"/>
          </p:cNvSpPr>
          <p:nvPr/>
        </p:nvSpPr>
        <p:spPr bwMode="auto">
          <a:xfrm rot="16200000">
            <a:off x="1741105" y="1581238"/>
            <a:ext cx="52228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9" name="TextBox 13"/>
          <p:cNvSpPr txBox="1">
            <a:spLocks noChangeArrowheads="1"/>
          </p:cNvSpPr>
          <p:nvPr/>
        </p:nvSpPr>
        <p:spPr bwMode="auto">
          <a:xfrm rot="16200000">
            <a:off x="1883715" y="1554721"/>
            <a:ext cx="56951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t3Δ</a:t>
            </a:r>
          </a:p>
        </p:txBody>
      </p:sp>
      <p:sp>
        <p:nvSpPr>
          <p:cNvPr id="10" name="TextBox 14"/>
          <p:cNvSpPr txBox="1">
            <a:spLocks noChangeArrowheads="1"/>
          </p:cNvSpPr>
          <p:nvPr/>
        </p:nvSpPr>
        <p:spPr bwMode="auto">
          <a:xfrm rot="16200000">
            <a:off x="1995311" y="1476511"/>
            <a:ext cx="712696" cy="2771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20Δ</a:t>
            </a:r>
          </a:p>
        </p:txBody>
      </p:sp>
      <p:sp>
        <p:nvSpPr>
          <p:cNvPr id="11" name="TextBox 16"/>
          <p:cNvSpPr txBox="1">
            <a:spLocks noChangeArrowheads="1"/>
          </p:cNvSpPr>
          <p:nvPr/>
        </p:nvSpPr>
        <p:spPr bwMode="auto">
          <a:xfrm rot="16200000">
            <a:off x="2367433" y="1487868"/>
            <a:ext cx="71989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31Δ</a:t>
            </a:r>
          </a:p>
        </p:txBody>
      </p:sp>
      <p:sp>
        <p:nvSpPr>
          <p:cNvPr id="12" name="TextBox 17"/>
          <p:cNvSpPr txBox="1">
            <a:spLocks noChangeArrowheads="1"/>
          </p:cNvSpPr>
          <p:nvPr/>
        </p:nvSpPr>
        <p:spPr bwMode="auto">
          <a:xfrm rot="16200000">
            <a:off x="2609330" y="1542623"/>
            <a:ext cx="58819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1Δ</a:t>
            </a:r>
          </a:p>
        </p:txBody>
      </p:sp>
      <p:sp>
        <p:nvSpPr>
          <p:cNvPr id="13" name="TextBox 18"/>
          <p:cNvSpPr txBox="1">
            <a:spLocks noChangeArrowheads="1"/>
          </p:cNvSpPr>
          <p:nvPr/>
        </p:nvSpPr>
        <p:spPr bwMode="auto">
          <a:xfrm rot="16200000">
            <a:off x="2768980" y="1531465"/>
            <a:ext cx="60761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5Δ</a:t>
            </a:r>
          </a:p>
        </p:txBody>
      </p:sp>
      <p:sp>
        <p:nvSpPr>
          <p:cNvPr id="14" name="TextBox 19"/>
          <p:cNvSpPr txBox="1">
            <a:spLocks noChangeArrowheads="1"/>
          </p:cNvSpPr>
          <p:nvPr/>
        </p:nvSpPr>
        <p:spPr bwMode="auto">
          <a:xfrm rot="16200000">
            <a:off x="3160150" y="1511955"/>
            <a:ext cx="64763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15Δ</a:t>
            </a:r>
          </a:p>
        </p:txBody>
      </p:sp>
      <p:sp>
        <p:nvSpPr>
          <p:cNvPr id="15" name="TextBox 21"/>
          <p:cNvSpPr txBox="1">
            <a:spLocks noChangeArrowheads="1"/>
          </p:cNvSpPr>
          <p:nvPr/>
        </p:nvSpPr>
        <p:spPr bwMode="auto">
          <a:xfrm rot="16200000">
            <a:off x="3375340" y="1530983"/>
            <a:ext cx="60664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2Δ</a:t>
            </a:r>
          </a:p>
        </p:txBody>
      </p:sp>
      <p:sp>
        <p:nvSpPr>
          <p:cNvPr id="16" name="TextBox 22"/>
          <p:cNvSpPr txBox="1">
            <a:spLocks noChangeArrowheads="1"/>
          </p:cNvSpPr>
          <p:nvPr/>
        </p:nvSpPr>
        <p:spPr bwMode="auto">
          <a:xfrm rot="16200000">
            <a:off x="3507997" y="1471915"/>
            <a:ext cx="68798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3Δ</a:t>
            </a:r>
          </a:p>
        </p:txBody>
      </p:sp>
      <p:sp>
        <p:nvSpPr>
          <p:cNvPr id="17" name="Minus 16"/>
          <p:cNvSpPr/>
          <p:nvPr/>
        </p:nvSpPr>
        <p:spPr>
          <a:xfrm>
            <a:off x="2323487" y="1318944"/>
            <a:ext cx="270971" cy="39523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Minus 17"/>
          <p:cNvSpPr/>
          <p:nvPr/>
        </p:nvSpPr>
        <p:spPr>
          <a:xfrm>
            <a:off x="2666071" y="1320480"/>
            <a:ext cx="303560" cy="46841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Minus 18"/>
          <p:cNvSpPr/>
          <p:nvPr/>
        </p:nvSpPr>
        <p:spPr>
          <a:xfrm flipV="1">
            <a:off x="2933050" y="1319158"/>
            <a:ext cx="1093389" cy="49556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Picture 19" descr="Screen Shot 2013-04-26 at 6.55.24 AM.png">
            <a:extLst>
              <a:ext uri="{FF2B5EF4-FFF2-40B4-BE49-F238E27FC236}">
                <a16:creationId xmlns:a16="http://schemas.microsoft.com/office/drawing/2014/main" xmlns="" id="{B8E76E7C-8D75-40AE-9994-438DCC47E9A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l="21626" t="-12378" r="45638" b="-16860"/>
          <a:stretch/>
        </p:blipFill>
        <p:spPr>
          <a:xfrm>
            <a:off x="3409303" y="2261427"/>
            <a:ext cx="562417" cy="243876"/>
          </a:xfrm>
          <a:prstGeom prst="rect">
            <a:avLst/>
          </a:prstGeom>
        </p:spPr>
      </p:pic>
      <p:pic>
        <p:nvPicPr>
          <p:cNvPr id="21" name="Picture 20" descr="Screen Shot 2013-04-26 at 6.55.13 AM.png">
            <a:extLst>
              <a:ext uri="{FF2B5EF4-FFF2-40B4-BE49-F238E27FC236}">
                <a16:creationId xmlns:a16="http://schemas.microsoft.com/office/drawing/2014/main" xmlns="" id="{90D08CEE-D0C2-4E6B-B0F6-1E021EB05088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1936372" y="2280791"/>
            <a:ext cx="1442939" cy="199555"/>
          </a:xfrm>
          <a:prstGeom prst="rect">
            <a:avLst/>
          </a:prstGeom>
        </p:spPr>
      </p:pic>
      <p:pic>
        <p:nvPicPr>
          <p:cNvPr id="22" name="Picture 21" descr="Screen Shot 2013-04-26 at 6.57.54 AM.png">
            <a:extLst>
              <a:ext uri="{FF2B5EF4-FFF2-40B4-BE49-F238E27FC236}">
                <a16:creationId xmlns:a16="http://schemas.microsoft.com/office/drawing/2014/main" xmlns="" id="{849B6289-0A9C-41EE-B11A-123C4CC1EB29}"/>
              </a:ext>
            </a:extLst>
          </p:cNvPr>
          <p:cNvPicPr>
            <a:picLocks noChangeAspect="1"/>
          </p:cNvPicPr>
          <p:nvPr/>
        </p:nvPicPr>
        <p:blipFill>
          <a:blip r:embed="rId4">
            <a:grayscl/>
          </a:blip>
          <a:stretch>
            <a:fillRect/>
          </a:stretch>
        </p:blipFill>
        <p:spPr>
          <a:xfrm>
            <a:off x="1936372" y="1934495"/>
            <a:ext cx="1442939" cy="316121"/>
          </a:xfrm>
          <a:prstGeom prst="rect">
            <a:avLst/>
          </a:prstGeom>
        </p:spPr>
      </p:pic>
      <p:pic>
        <p:nvPicPr>
          <p:cNvPr id="23" name="Picture 22" descr="Screen Shot 2013-04-26 at 6.58.03 AM.png">
            <a:extLst>
              <a:ext uri="{FF2B5EF4-FFF2-40B4-BE49-F238E27FC236}">
                <a16:creationId xmlns:a16="http://schemas.microsoft.com/office/drawing/2014/main" xmlns="" id="{02D90318-01AD-4915-B638-9315D581893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</a:blip>
          <a:srcRect l="21148" t="1" r="45754" b="3297"/>
          <a:stretch/>
        </p:blipFill>
        <p:spPr>
          <a:xfrm>
            <a:off x="3409304" y="1922212"/>
            <a:ext cx="562647" cy="328403"/>
          </a:xfrm>
          <a:prstGeom prst="rect">
            <a:avLst/>
          </a:prstGeom>
        </p:spPr>
      </p:pic>
      <p:sp>
        <p:nvSpPr>
          <p:cNvPr id="24" name="TextBox 14">
            <a:extLst>
              <a:ext uri="{FF2B5EF4-FFF2-40B4-BE49-F238E27FC236}">
                <a16:creationId xmlns:a16="http://schemas.microsoft.com/office/drawing/2014/main" xmlns="" id="{572FE7B2-6A15-4501-B7F7-008B73A8A51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178531" y="1474785"/>
            <a:ext cx="709242" cy="2771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18Δ</a:t>
            </a:r>
          </a:p>
        </p:txBody>
      </p:sp>
      <p:sp>
        <p:nvSpPr>
          <p:cNvPr id="25" name="TextBox 14">
            <a:extLst>
              <a:ext uri="{FF2B5EF4-FFF2-40B4-BE49-F238E27FC236}">
                <a16:creationId xmlns:a16="http://schemas.microsoft.com/office/drawing/2014/main" xmlns="" id="{522A12B0-E6BD-474B-BAF0-9CBB3307FF6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97584" y="1471165"/>
            <a:ext cx="701999" cy="2771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16Δ</a:t>
            </a:r>
          </a:p>
        </p:txBody>
      </p:sp>
      <p:graphicFrame>
        <p:nvGraphicFramePr>
          <p:cNvPr id="26" name="Chart 25"/>
          <p:cNvGraphicFramePr/>
          <p:nvPr>
            <p:extLst/>
          </p:nvPr>
        </p:nvGraphicFramePr>
        <p:xfrm>
          <a:off x="477789" y="3385618"/>
          <a:ext cx="5750747" cy="2485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7" name="Rectangle 26"/>
          <p:cNvSpPr/>
          <p:nvPr/>
        </p:nvSpPr>
        <p:spPr>
          <a:xfrm>
            <a:off x="4731798" y="3320249"/>
            <a:ext cx="1562470" cy="27254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1261391" y="5335479"/>
            <a:ext cx="3583602" cy="6006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390618" y="3320249"/>
            <a:ext cx="4418863" cy="975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456640" y="5838634"/>
            <a:ext cx="4418863" cy="975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412057" y="3375865"/>
            <a:ext cx="164993" cy="26698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11"/>
          <p:cNvSpPr txBox="1">
            <a:spLocks noChangeArrowheads="1"/>
          </p:cNvSpPr>
          <p:nvPr/>
        </p:nvSpPr>
        <p:spPr bwMode="auto">
          <a:xfrm rot="16200000">
            <a:off x="1167225" y="5272244"/>
            <a:ext cx="55520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45" name="TextBox 13"/>
          <p:cNvSpPr txBox="1">
            <a:spLocks noChangeArrowheads="1"/>
          </p:cNvSpPr>
          <p:nvPr/>
        </p:nvSpPr>
        <p:spPr bwMode="auto">
          <a:xfrm rot="16200000">
            <a:off x="1529905" y="5400353"/>
            <a:ext cx="49851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t3Δ</a:t>
            </a:r>
          </a:p>
        </p:txBody>
      </p:sp>
      <p:sp>
        <p:nvSpPr>
          <p:cNvPr id="46" name="TextBox 14"/>
          <p:cNvSpPr txBox="1">
            <a:spLocks noChangeArrowheads="1"/>
          </p:cNvSpPr>
          <p:nvPr/>
        </p:nvSpPr>
        <p:spPr bwMode="auto">
          <a:xfrm rot="16200000">
            <a:off x="1746869" y="5464968"/>
            <a:ext cx="659591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20Δ</a:t>
            </a:r>
          </a:p>
        </p:txBody>
      </p:sp>
      <p:sp>
        <p:nvSpPr>
          <p:cNvPr id="47" name="TextBox 16"/>
          <p:cNvSpPr txBox="1">
            <a:spLocks noChangeArrowheads="1"/>
          </p:cNvSpPr>
          <p:nvPr/>
        </p:nvSpPr>
        <p:spPr bwMode="auto">
          <a:xfrm rot="16200000">
            <a:off x="2409050" y="5455894"/>
            <a:ext cx="64621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31Δ</a:t>
            </a:r>
          </a:p>
        </p:txBody>
      </p:sp>
      <p:sp>
        <p:nvSpPr>
          <p:cNvPr id="48" name="TextBox 17"/>
          <p:cNvSpPr txBox="1">
            <a:spLocks noChangeArrowheads="1"/>
          </p:cNvSpPr>
          <p:nvPr/>
        </p:nvSpPr>
        <p:spPr bwMode="auto">
          <a:xfrm rot="16200000">
            <a:off x="2724622" y="5400352"/>
            <a:ext cx="62527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1Δ</a:t>
            </a:r>
          </a:p>
        </p:txBody>
      </p:sp>
      <p:sp>
        <p:nvSpPr>
          <p:cNvPr id="49" name="TextBox 18"/>
          <p:cNvSpPr txBox="1">
            <a:spLocks noChangeArrowheads="1"/>
          </p:cNvSpPr>
          <p:nvPr/>
        </p:nvSpPr>
        <p:spPr bwMode="auto">
          <a:xfrm rot="16200000">
            <a:off x="3041107" y="5433961"/>
            <a:ext cx="59544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5Δ</a:t>
            </a:r>
          </a:p>
        </p:txBody>
      </p:sp>
      <p:sp>
        <p:nvSpPr>
          <p:cNvPr id="50" name="TextBox 19"/>
          <p:cNvSpPr txBox="1">
            <a:spLocks noChangeArrowheads="1"/>
          </p:cNvSpPr>
          <p:nvPr/>
        </p:nvSpPr>
        <p:spPr bwMode="auto">
          <a:xfrm rot="16200000">
            <a:off x="3350196" y="5464968"/>
            <a:ext cx="64524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16Δ</a:t>
            </a:r>
          </a:p>
        </p:txBody>
      </p:sp>
      <p:sp>
        <p:nvSpPr>
          <p:cNvPr id="51" name="TextBox 21"/>
          <p:cNvSpPr txBox="1">
            <a:spLocks noChangeArrowheads="1"/>
          </p:cNvSpPr>
          <p:nvPr/>
        </p:nvSpPr>
        <p:spPr bwMode="auto">
          <a:xfrm rot="16200000">
            <a:off x="4031993" y="5450961"/>
            <a:ext cx="57940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2Δ</a:t>
            </a:r>
          </a:p>
        </p:txBody>
      </p:sp>
      <p:sp>
        <p:nvSpPr>
          <p:cNvPr id="52" name="TextBox 22"/>
          <p:cNvSpPr txBox="1">
            <a:spLocks noChangeArrowheads="1"/>
          </p:cNvSpPr>
          <p:nvPr/>
        </p:nvSpPr>
        <p:spPr bwMode="auto">
          <a:xfrm rot="16200000">
            <a:off x="4342031" y="5433960"/>
            <a:ext cx="58035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3Δ</a:t>
            </a:r>
          </a:p>
        </p:txBody>
      </p:sp>
      <p:sp>
        <p:nvSpPr>
          <p:cNvPr id="56" name="TextBox 14"/>
          <p:cNvSpPr txBox="1">
            <a:spLocks noChangeArrowheads="1"/>
          </p:cNvSpPr>
          <p:nvPr/>
        </p:nvSpPr>
        <p:spPr bwMode="auto">
          <a:xfrm rot="16200000">
            <a:off x="2068081" y="5464968"/>
            <a:ext cx="659591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18Δ</a:t>
            </a:r>
            <a:endParaRPr lang="en-US" altLang="en-US" sz="11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21"/>
          <p:cNvSpPr txBox="1">
            <a:spLocks noChangeArrowheads="1"/>
          </p:cNvSpPr>
          <p:nvPr/>
        </p:nvSpPr>
        <p:spPr bwMode="auto">
          <a:xfrm rot="16200000">
            <a:off x="3653814" y="5457058"/>
            <a:ext cx="66111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37931725" indent="-37474525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i="1">
                <a:latin typeface="Times New Roman" panose="02020603050405020304" pitchFamily="18" charset="0"/>
                <a:cs typeface="Times New Roman" panose="02020603050405020304" pitchFamily="18" charset="0"/>
              </a:rPr>
              <a:t>med15Δ</a:t>
            </a:r>
            <a:endParaRPr lang="en-US" altLang="en-US" sz="11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84286" y="672353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 Figure</a:t>
            </a:r>
            <a:endParaRPr lang="en-US" dirty="0"/>
          </a:p>
        </p:txBody>
      </p:sp>
      <p:sp>
        <p:nvSpPr>
          <p:cNvPr id="59" name="TextBox 58"/>
          <p:cNvSpPr txBox="1"/>
          <p:nvPr/>
        </p:nvSpPr>
        <p:spPr>
          <a:xfrm>
            <a:off x="1521329" y="753526"/>
            <a:ext cx="4908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charset="0"/>
                <a:ea typeface="Times New Roman" charset="0"/>
                <a:cs typeface="Times New Roman" charset="0"/>
              </a:rPr>
              <a:t>A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324885" y="3186962"/>
            <a:ext cx="5303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charset="0"/>
                <a:ea typeface="Times New Roman" charset="0"/>
                <a:cs typeface="Times New Roman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02825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46</Words>
  <Application>Microsoft Macintosh PowerPoint</Application>
  <PresentationFormat>Custom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PGothic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se, Randall H (HEALTH)</dc:creator>
  <cp:lastModifiedBy>Morse, Randall H (HEALTH)</cp:lastModifiedBy>
  <cp:revision>1</cp:revision>
  <dcterms:created xsi:type="dcterms:W3CDTF">2017-12-18T19:35:06Z</dcterms:created>
  <dcterms:modified xsi:type="dcterms:W3CDTF">2017-12-18T19:36:11Z</dcterms:modified>
</cp:coreProperties>
</file>